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3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5B3B2BF-C58A-4E29-8383-59408EDEDD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5A55253E-FF39-42C9-A35F-9D1D727B7A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5AABF45-667D-47FA-B1B0-AC15BB3C6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8837DE8-E3E1-47A3-BC6C-A27EF50A7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514FC62-B630-410E-8BFA-CF24E31AF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12346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9F30D04-A1F9-4DD7-8928-E0F9504CD6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53A386CC-9563-465C-BDF7-63D646A4B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0F09E06C-C5C5-4B81-A00E-5C3CADD7A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0F38D49B-DD88-430B-B147-089C585CE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06103EA4-D199-4044-BF97-2811576CF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81345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385CF241-E057-4308-8711-3F90F19F20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DE8ED1C3-BB93-4537-B182-3ED2728E22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7833666-C20E-4800-983D-8D94FB962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F698C0BA-2385-48BB-983B-D37E9CF80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CC5E4F4-BC53-4603-B191-E33225E46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0114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ACA0BD6-5867-42F6-B3FB-3BF5993B90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E58AF39B-3581-4123-B8B7-317D239A1B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47B17F94-8E9F-46FA-91EF-187B2BA70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B9B7D717-F298-45AC-98D4-E783B1060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A034BE3E-55CC-4169-9E8F-842287A9B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8104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7DC1DDD-14C5-453E-8D6E-5A1276347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DF7A0993-5637-4E44-BEB9-9659354C28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18DB037-F193-4C0B-BA67-88EE9424F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4EDB182-8D8B-4C52-9FAF-CBC480C40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F4B497B-642C-42AB-AD79-F5578423F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27235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7E0659C-F57E-4575-A158-5F1150652E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503B3672-32CB-4871-A1B3-D6C085A427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54FE93C7-CE71-432B-B082-2DCB6E939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13E18D6-5917-4152-B96D-64EFA85D6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7BB4285F-E32C-4975-9652-8A04518C2A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53635285-D83C-4984-A9EF-71B1724AF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23707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110FA88-3D13-4EDA-9E6F-D1F47EC51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2FF12A33-9981-4260-9ED4-250593E3F2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081B0F3C-920A-4E07-A0FF-48D4728D66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82C2AC9E-6B8F-4A63-B5C4-794E672760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D974C0C1-0124-4421-9106-9F89F70126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1A385D9B-E5F8-4A68-AB88-BFBF55810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05DF3648-46DA-4A10-AF76-8FFAF03DE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9B53FA67-6654-4319-AC36-F2C392BDF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07039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10770004-B468-4186-AC9F-D878676673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9BF28301-4F05-401A-B5AC-07DA50F34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7F9950E4-55F6-44DF-8EED-231FB5CD46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3B0E6796-74A6-49BD-A290-959AFCCB9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43614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3506BFD0-BE0F-406E-A7F8-74FEE0392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0F690540-571E-4D09-A302-465C25B8C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4DE28306-CF1D-4E5A-B2BA-841B36E0F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42228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127CDD2-0B06-4E2F-982C-F834CC16FF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07EA2D52-E33D-4EEF-A85F-EE4A41E527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513C3D6A-1993-483D-8674-728918BE1A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0DB8A393-B0BD-4883-A331-BA5867792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48D870D3-DF3D-4376-8F0C-3F3967395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4EABACD0-2FD7-439D-A079-35AE23946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79338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D06025E4-7361-42C4-8177-20F7BE765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4E0868B9-7F81-4C04-B69C-67F02BE99E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A870D69B-254C-42F8-A716-5A26074EA9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3579112D-2250-446E-93E3-3D42DFE7B6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95870636-98E9-4B81-8D88-AEE691AD1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68F67AB3-B7C3-454B-AF3B-049FA2C2F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69819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A09B8D99-4411-43DA-A3FC-94957C6F4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A5770139-78DE-401D-BC2C-30B271430D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FA42B12-6894-4A8E-88BF-50B376ED88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B8310-DDBF-4E75-A7F6-BF03578AB4F1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C50E413B-FBB2-4CB3-8B96-67094F0109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5984911-F71B-468A-965A-168CF1BCA6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62A9E-76D4-4F4A-9277-5773B8EA7744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30278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e 2">
            <a:extLst>
              <a:ext uri="{FF2B5EF4-FFF2-40B4-BE49-F238E27FC236}">
                <a16:creationId xmlns:a16="http://schemas.microsoft.com/office/drawing/2014/main" id="{FFF1CBD6-F13B-4340-A454-E2C5CC56B4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200" y="426933"/>
            <a:ext cx="7419600" cy="5399474"/>
          </a:xfrm>
          <a:prstGeom prst="rect">
            <a:avLst/>
          </a:prstGeom>
          <a:ln w="12700">
            <a:solidFill>
              <a:schemeClr val="accent1"/>
            </a:solidFill>
          </a:ln>
        </p:spPr>
      </p:pic>
      <p:sp>
        <p:nvSpPr>
          <p:cNvPr id="4" name="TekstSylinder 3">
            <a:extLst>
              <a:ext uri="{FF2B5EF4-FFF2-40B4-BE49-F238E27FC236}">
                <a16:creationId xmlns:a16="http://schemas.microsoft.com/office/drawing/2014/main" id="{8BEA7539-C54B-4A9E-B270-443AC3E437D3}"/>
              </a:ext>
            </a:extLst>
          </p:cNvPr>
          <p:cNvSpPr txBox="1"/>
          <p:nvPr/>
        </p:nvSpPr>
        <p:spPr>
          <a:xfrm>
            <a:off x="873760" y="5963920"/>
            <a:ext cx="6959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A. </a:t>
            </a:r>
            <a:r>
              <a:rPr lang="nb-NO" dirty="0" err="1"/>
              <a:t>Cumulative</a:t>
            </a:r>
            <a:r>
              <a:rPr lang="nb-NO" dirty="0"/>
              <a:t> </a:t>
            </a:r>
            <a:r>
              <a:rPr lang="nb-NO" dirty="0" err="1"/>
              <a:t>incidence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death</a:t>
            </a:r>
            <a:r>
              <a:rPr lang="nb-NO" dirty="0"/>
              <a:t> </a:t>
            </a:r>
            <a:r>
              <a:rPr lang="nb-NO" dirty="0" err="1"/>
              <a:t>according</a:t>
            </a:r>
            <a:r>
              <a:rPr lang="nb-NO" dirty="0"/>
              <a:t> to </a:t>
            </a:r>
            <a:r>
              <a:rPr lang="nb-NO" dirty="0" err="1"/>
              <a:t>gender</a:t>
            </a:r>
            <a:r>
              <a:rPr lang="nb-NO" dirty="0"/>
              <a:t> </a:t>
            </a:r>
            <a:r>
              <a:rPr lang="nb-NO" dirty="0" err="1"/>
              <a:t>among</a:t>
            </a:r>
            <a:r>
              <a:rPr lang="nb-NO" dirty="0"/>
              <a:t> 105 </a:t>
            </a:r>
            <a:r>
              <a:rPr lang="nb-NO" dirty="0" err="1"/>
              <a:t>patients</a:t>
            </a:r>
            <a:r>
              <a:rPr lang="nb-NO" dirty="0"/>
              <a:t> </a:t>
            </a:r>
            <a:r>
              <a:rPr lang="nb-NO" dirty="0" err="1"/>
              <a:t>presenting</a:t>
            </a:r>
            <a:r>
              <a:rPr lang="nb-NO" dirty="0"/>
              <a:t>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variceal</a:t>
            </a:r>
            <a:r>
              <a:rPr lang="nb-NO" dirty="0"/>
              <a:t> </a:t>
            </a:r>
            <a:r>
              <a:rPr lang="nb-NO" dirty="0" err="1"/>
              <a:t>bleeding</a:t>
            </a:r>
            <a:r>
              <a:rPr lang="nb-NO" dirty="0"/>
              <a:t> (p=0.002).</a:t>
            </a:r>
          </a:p>
        </p:txBody>
      </p:sp>
    </p:spTree>
    <p:extLst>
      <p:ext uri="{BB962C8B-B14F-4D97-AF65-F5344CB8AC3E}">
        <p14:creationId xmlns:p14="http://schemas.microsoft.com/office/powerpoint/2010/main" val="2974764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de 2">
            <a:extLst>
              <a:ext uri="{FF2B5EF4-FFF2-40B4-BE49-F238E27FC236}">
                <a16:creationId xmlns:a16="http://schemas.microsoft.com/office/drawing/2014/main" id="{0BAF1DCD-FFD8-4C55-AC91-C44115F2A1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200" y="335493"/>
            <a:ext cx="7419600" cy="53994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kstSylinder 3">
            <a:extLst>
              <a:ext uri="{FF2B5EF4-FFF2-40B4-BE49-F238E27FC236}">
                <a16:creationId xmlns:a16="http://schemas.microsoft.com/office/drawing/2014/main" id="{7CF83C1C-76F0-414C-A094-A8B6DF7FD539}"/>
              </a:ext>
            </a:extLst>
          </p:cNvPr>
          <p:cNvSpPr txBox="1"/>
          <p:nvPr/>
        </p:nvSpPr>
        <p:spPr>
          <a:xfrm>
            <a:off x="873760" y="5892800"/>
            <a:ext cx="6959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B. </a:t>
            </a:r>
            <a:r>
              <a:rPr lang="nb-NO" dirty="0" err="1"/>
              <a:t>Cumulative</a:t>
            </a:r>
            <a:r>
              <a:rPr lang="nb-NO" dirty="0"/>
              <a:t> </a:t>
            </a:r>
            <a:r>
              <a:rPr lang="nb-NO" dirty="0" err="1"/>
              <a:t>incidence</a:t>
            </a:r>
            <a:r>
              <a:rPr lang="nb-NO" dirty="0"/>
              <a:t> </a:t>
            </a:r>
            <a:r>
              <a:rPr lang="nb-NO" dirty="0" err="1"/>
              <a:t>of</a:t>
            </a:r>
            <a:r>
              <a:rPr lang="nb-NO" dirty="0"/>
              <a:t> </a:t>
            </a:r>
            <a:r>
              <a:rPr lang="nb-NO" dirty="0" err="1"/>
              <a:t>death</a:t>
            </a:r>
            <a:r>
              <a:rPr lang="nb-NO" dirty="0"/>
              <a:t> </a:t>
            </a:r>
            <a:r>
              <a:rPr lang="nb-NO" dirty="0" err="1"/>
              <a:t>according</a:t>
            </a:r>
            <a:r>
              <a:rPr lang="nb-NO" dirty="0"/>
              <a:t> to </a:t>
            </a:r>
            <a:r>
              <a:rPr lang="nb-NO" dirty="0" err="1"/>
              <a:t>gender</a:t>
            </a:r>
            <a:r>
              <a:rPr lang="nb-NO" dirty="0"/>
              <a:t> </a:t>
            </a:r>
            <a:r>
              <a:rPr lang="nb-NO" dirty="0" err="1"/>
              <a:t>among</a:t>
            </a:r>
            <a:r>
              <a:rPr lang="nb-NO" dirty="0"/>
              <a:t> 161 </a:t>
            </a:r>
            <a:r>
              <a:rPr lang="nb-NO" dirty="0" err="1"/>
              <a:t>patients</a:t>
            </a:r>
            <a:r>
              <a:rPr lang="nb-NO" dirty="0"/>
              <a:t> not </a:t>
            </a:r>
            <a:r>
              <a:rPr lang="nb-NO" dirty="0" err="1"/>
              <a:t>presenting</a:t>
            </a:r>
            <a:r>
              <a:rPr lang="nb-NO" dirty="0"/>
              <a:t> </a:t>
            </a:r>
            <a:r>
              <a:rPr lang="nb-NO" dirty="0" err="1"/>
              <a:t>with</a:t>
            </a:r>
            <a:r>
              <a:rPr lang="nb-NO" dirty="0"/>
              <a:t> </a:t>
            </a:r>
            <a:r>
              <a:rPr lang="nb-NO" dirty="0" err="1"/>
              <a:t>variceal</a:t>
            </a:r>
            <a:r>
              <a:rPr lang="nb-NO" dirty="0"/>
              <a:t> </a:t>
            </a:r>
            <a:r>
              <a:rPr lang="nb-NO" dirty="0" err="1"/>
              <a:t>bleeding</a:t>
            </a:r>
            <a:r>
              <a:rPr lang="nb-NO" dirty="0"/>
              <a:t> (p=0.448).</a:t>
            </a:r>
          </a:p>
        </p:txBody>
      </p:sp>
    </p:spTree>
    <p:extLst>
      <p:ext uri="{BB962C8B-B14F-4D97-AF65-F5344CB8AC3E}">
        <p14:creationId xmlns:p14="http://schemas.microsoft.com/office/powerpoint/2010/main" val="3538173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3</Words>
  <Application>Microsoft Office PowerPoint</Application>
  <PresentationFormat>Skjermfremvisning (4:3)</PresentationFormat>
  <Paragraphs>2</Paragraphs>
  <Slides>2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owerPoint-presentasjon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 </dc:creator>
  <cp:lastModifiedBy> </cp:lastModifiedBy>
  <cp:revision>5</cp:revision>
  <dcterms:created xsi:type="dcterms:W3CDTF">2019-08-12T06:05:47Z</dcterms:created>
  <dcterms:modified xsi:type="dcterms:W3CDTF">2019-09-19T14:19:45Z</dcterms:modified>
</cp:coreProperties>
</file>